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6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7040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6317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5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6087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4503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167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2565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02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6366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8462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1678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1462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/>
          <p:cNvSpPr/>
          <p:nvPr/>
        </p:nvSpPr>
        <p:spPr>
          <a:xfrm>
            <a:off x="464203" y="119655"/>
            <a:ext cx="110871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Q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quantile-quantile) of the GWAS analysis for osmotic adjustment (OA), RWC-s, RWC-c, LR using two different Mixed Linear Models (MLM) approaches: A) MLM with K (kinship matrix), B) MLM with K (kinship matrix) and Q (Populatio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usctu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cluding flowering time as covariate which used in the study.</a:t>
            </a:r>
          </a:p>
        </p:txBody>
      </p:sp>
      <p:sp>
        <p:nvSpPr>
          <p:cNvPr id="7" name="Rettangolo 6"/>
          <p:cNvSpPr/>
          <p:nvPr/>
        </p:nvSpPr>
        <p:spPr>
          <a:xfrm>
            <a:off x="3249641" y="925945"/>
            <a:ext cx="40748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400" b="1" cap="none" spc="0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Rettangolo 7"/>
          <p:cNvSpPr/>
          <p:nvPr/>
        </p:nvSpPr>
        <p:spPr>
          <a:xfrm>
            <a:off x="3234835" y="3975530"/>
            <a:ext cx="389851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400" b="1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24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Immagin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8365" y="1215097"/>
            <a:ext cx="4634116" cy="2574509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8365" y="4083269"/>
            <a:ext cx="4634116" cy="25745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463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3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CONDORELLI</cp:lastModifiedBy>
  <cp:revision>17</cp:revision>
  <dcterms:created xsi:type="dcterms:W3CDTF">2018-07-25T07:55:45Z</dcterms:created>
  <dcterms:modified xsi:type="dcterms:W3CDTF">2021-12-10T16:39:29Z</dcterms:modified>
</cp:coreProperties>
</file>